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40EE342A-5E9B-4420-8C8A-4FDB470172D0}">
          <p14:sldIdLst>
            <p14:sldId id="25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63"/>
    <p:restoredTop sz="94713"/>
  </p:normalViewPr>
  <p:slideViewPr>
    <p:cSldViewPr snapToGrid="0" snapToObjects="1">
      <p:cViewPr varScale="1">
        <p:scale>
          <a:sx n="68" d="100"/>
          <a:sy n="68" d="100"/>
        </p:scale>
        <p:origin x="1554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ujimotoryou:Desktop:lncRNA%202nd:ncRNA_mCLv_IRR_siRN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cRNA!$H$3</c:f>
              <c:strCache>
                <c:ptCount val="1"/>
                <c:pt idx="0">
                  <c:v>C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ncRNA!$G$4:$G$9</c:f>
              <c:strCache>
                <c:ptCount val="6"/>
                <c:pt idx="0">
                  <c:v>lincRNA</c:v>
                </c:pt>
                <c:pt idx="1">
                  <c:v>NAT</c:v>
                </c:pt>
                <c:pt idx="2">
                  <c:v>incRNA </c:v>
                </c:pt>
                <c:pt idx="3">
                  <c:v>putative mRNA</c:v>
                </c:pt>
                <c:pt idx="4">
                  <c:v>Total</c:v>
                </c:pt>
                <c:pt idx="5">
                  <c:v>IRRs</c:v>
                </c:pt>
              </c:strCache>
            </c:strRef>
          </c:cat>
          <c:val>
            <c:numRef>
              <c:f>ncRNA!$H$4:$H$9</c:f>
              <c:numCache>
                <c:formatCode>0%</c:formatCode>
                <c:ptCount val="6"/>
                <c:pt idx="0">
                  <c:v>0.31143300000000002</c:v>
                </c:pt>
                <c:pt idx="1">
                  <c:v>0.193772</c:v>
                </c:pt>
                <c:pt idx="2">
                  <c:v>0.31621500000000002</c:v>
                </c:pt>
                <c:pt idx="3">
                  <c:v>0.35634300000000002</c:v>
                </c:pt>
                <c:pt idx="4" formatCode="0.0%">
                  <c:v>0.36539238624411502</c:v>
                </c:pt>
                <c:pt idx="5" formatCode="0.00%">
                  <c:v>0.73734555216831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9E-4D16-B82C-9A53F38443C3}"/>
            </c:ext>
          </c:extLst>
        </c:ser>
        <c:ser>
          <c:idx val="1"/>
          <c:order val="1"/>
          <c:tx>
            <c:strRef>
              <c:f>ncRNA!$I$3</c:f>
              <c:strCache>
                <c:ptCount val="1"/>
                <c:pt idx="0">
                  <c:v>CHG</c:v>
                </c:pt>
              </c:strCache>
            </c:strRef>
          </c:tx>
          <c:spPr>
            <a:solidFill>
              <a:srgbClr val="3366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ncRNA!$G$4:$G$9</c:f>
              <c:strCache>
                <c:ptCount val="6"/>
                <c:pt idx="0">
                  <c:v>lincRNA</c:v>
                </c:pt>
                <c:pt idx="1">
                  <c:v>NAT</c:v>
                </c:pt>
                <c:pt idx="2">
                  <c:v>incRNA </c:v>
                </c:pt>
                <c:pt idx="3">
                  <c:v>putative mRNA</c:v>
                </c:pt>
                <c:pt idx="4">
                  <c:v>Total</c:v>
                </c:pt>
                <c:pt idx="5">
                  <c:v>IRRs</c:v>
                </c:pt>
              </c:strCache>
            </c:strRef>
          </c:cat>
          <c:val>
            <c:numRef>
              <c:f>ncRNA!$I$4:$I$9</c:f>
              <c:numCache>
                <c:formatCode>0%</c:formatCode>
                <c:ptCount val="6"/>
                <c:pt idx="0">
                  <c:v>0.12430099999999999</c:v>
                </c:pt>
                <c:pt idx="1">
                  <c:v>8.0401899999999998E-2</c:v>
                </c:pt>
                <c:pt idx="2">
                  <c:v>0.13757900000000001</c:v>
                </c:pt>
                <c:pt idx="3">
                  <c:v>0.132879</c:v>
                </c:pt>
                <c:pt idx="4" formatCode="0.0%">
                  <c:v>0.13442547281730699</c:v>
                </c:pt>
                <c:pt idx="5" formatCode="0.00%">
                  <c:v>0.33758801213565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9E-4D16-B82C-9A53F38443C3}"/>
            </c:ext>
          </c:extLst>
        </c:ser>
        <c:ser>
          <c:idx val="2"/>
          <c:order val="2"/>
          <c:tx>
            <c:strRef>
              <c:f>ncRNA!$J$3</c:f>
              <c:strCache>
                <c:ptCount val="1"/>
                <c:pt idx="0">
                  <c:v>CH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ncRNA!$G$4:$G$9</c:f>
              <c:strCache>
                <c:ptCount val="6"/>
                <c:pt idx="0">
                  <c:v>lincRNA</c:v>
                </c:pt>
                <c:pt idx="1">
                  <c:v>NAT</c:v>
                </c:pt>
                <c:pt idx="2">
                  <c:v>incRNA </c:v>
                </c:pt>
                <c:pt idx="3">
                  <c:v>putative mRNA</c:v>
                </c:pt>
                <c:pt idx="4">
                  <c:v>Total</c:v>
                </c:pt>
                <c:pt idx="5">
                  <c:v>IRRs</c:v>
                </c:pt>
              </c:strCache>
            </c:strRef>
          </c:cat>
          <c:val>
            <c:numRef>
              <c:f>ncRNA!$J$4:$J$9</c:f>
              <c:numCache>
                <c:formatCode>0%</c:formatCode>
                <c:ptCount val="6"/>
                <c:pt idx="0">
                  <c:v>5.00086E-2</c:v>
                </c:pt>
                <c:pt idx="1">
                  <c:v>3.3373E-2</c:v>
                </c:pt>
                <c:pt idx="2">
                  <c:v>4.7307099999999998E-2</c:v>
                </c:pt>
                <c:pt idx="3">
                  <c:v>4.7582600000000003E-2</c:v>
                </c:pt>
                <c:pt idx="4" formatCode="0.0%">
                  <c:v>5.3406728518691202E-2</c:v>
                </c:pt>
                <c:pt idx="5" formatCode="0.00%">
                  <c:v>0.12989334485208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D9E-4D16-B82C-9A53F38443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964490528"/>
        <c:axId val="-964488752"/>
      </c:barChart>
      <c:catAx>
        <c:axId val="-964490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-964488752"/>
        <c:crosses val="autoZero"/>
        <c:auto val="1"/>
        <c:lblAlgn val="ctr"/>
        <c:lblOffset val="100"/>
        <c:noMultiLvlLbl val="0"/>
      </c:catAx>
      <c:valAx>
        <c:axId val="-96448875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 altLang="ja-JP"/>
                  <a:t>Methylation</a:t>
                </a:r>
                <a:r>
                  <a:rPr lang="en-US" altLang="ja-JP" baseline="0"/>
                  <a:t> level</a:t>
                </a:r>
                <a:endParaRPr lang="ja-JP" altLang="en-US"/>
              </a:p>
            </c:rich>
          </c:tx>
          <c:layout>
            <c:manualLayout>
              <c:xMode val="edge"/>
              <c:yMode val="edge"/>
              <c:x val="1.6666666666666701E-2"/>
              <c:y val="0.24353747448235599"/>
            </c:manualLayout>
          </c:layout>
          <c:overlay val="0"/>
        </c:title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-964490528"/>
        <c:crosses val="autoZero"/>
        <c:crossBetween val="between"/>
      </c:valAx>
    </c:plotArea>
    <c:legend>
      <c:legendPos val="r"/>
      <c:overlay val="0"/>
      <c:txPr>
        <a:bodyPr/>
        <a:lstStyle/>
        <a:p>
          <a:pPr>
            <a:defRPr lang="ja-JP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9F0532-8B7E-CE48-993A-6077FECB7158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8C7068-3195-864D-BDB0-7E17389584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04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8C7068-3195-864D-BDB0-7E173895842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60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4763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020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5032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406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554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86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42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123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76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001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596EC-571B-7A49-9A34-F29CC058F63B}" type="datetimeFigureOut">
              <a:rPr kumimoji="1" lang="ja-JP" altLang="en-US" smtClean="0"/>
              <a:t>2021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25F0D-CF83-524D-8CAC-9764351099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681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6886830"/>
              </p:ext>
            </p:extLst>
          </p:nvPr>
        </p:nvGraphicFramePr>
        <p:xfrm>
          <a:off x="2026201" y="189668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8151995" y="2185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2 Fig.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083734" y="4780942"/>
            <a:ext cx="6456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2 Fig. DNA methylation level of each type of </a:t>
            </a:r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putative mRNA, total, and IRRs. “Total” represents the DNA methylation level of all regions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36193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53</TotalTime>
  <Words>38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Yu Gothic</vt:lpstr>
      <vt:lpstr>Arial</vt:lpstr>
      <vt:lpstr>Calibri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moto</dc:creator>
  <cp:lastModifiedBy>Vijayakumar A478</cp:lastModifiedBy>
  <cp:revision>103</cp:revision>
  <cp:lastPrinted>2020-09-24T05:48:32Z</cp:lastPrinted>
  <dcterms:created xsi:type="dcterms:W3CDTF">2019-06-11T01:58:39Z</dcterms:created>
  <dcterms:modified xsi:type="dcterms:W3CDTF">2021-03-24T01:11:47Z</dcterms:modified>
</cp:coreProperties>
</file>